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1134" y="-288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2D45B6-355D-4D90-8000-F553593D731E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A5532D-3DEB-494C-A3A4-DA024CAED60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8037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1B9620-70C4-4AA8-B4B5-086C5B4B2E4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7771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3C29B-FF68-46C7-8D6A-9E5D5028C11F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D2149-CCD9-4FED-9C19-D876F7637C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162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3C29B-FF68-46C7-8D6A-9E5D5028C11F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D2149-CCD9-4FED-9C19-D876F7637C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594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3C29B-FF68-46C7-8D6A-9E5D5028C11F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D2149-CCD9-4FED-9C19-D876F7637C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5996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3C29B-FF68-46C7-8D6A-9E5D5028C11F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D2149-CCD9-4FED-9C19-D876F7637C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755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3C29B-FF68-46C7-8D6A-9E5D5028C11F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D2149-CCD9-4FED-9C19-D876F7637C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093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3C29B-FF68-46C7-8D6A-9E5D5028C11F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D2149-CCD9-4FED-9C19-D876F7637C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969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3C29B-FF68-46C7-8D6A-9E5D5028C11F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D2149-CCD9-4FED-9C19-D876F7637C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043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3C29B-FF68-46C7-8D6A-9E5D5028C11F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D2149-CCD9-4FED-9C19-D876F7637C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4983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3C29B-FF68-46C7-8D6A-9E5D5028C11F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D2149-CCD9-4FED-9C19-D876F7637C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047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3C29B-FF68-46C7-8D6A-9E5D5028C11F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D2149-CCD9-4FED-9C19-D876F7637C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259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3C29B-FF68-46C7-8D6A-9E5D5028C11F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D2149-CCD9-4FED-9C19-D876F7637C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0161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F3C29B-FF68-46C7-8D6A-9E5D5028C11F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2D2149-CCD9-4FED-9C19-D876F7637C5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201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422" y="1293132"/>
            <a:ext cx="6002607" cy="36221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4" name="Groupe 13"/>
          <p:cNvGrpSpPr/>
          <p:nvPr/>
        </p:nvGrpSpPr>
        <p:grpSpPr>
          <a:xfrm>
            <a:off x="553065" y="5535904"/>
            <a:ext cx="5795962" cy="1161944"/>
            <a:chOff x="1732672" y="2423208"/>
            <a:chExt cx="7499985" cy="1691592"/>
          </a:xfrm>
        </p:grpSpPr>
        <p:pic>
          <p:nvPicPr>
            <p:cNvPr id="15" name="Image 1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32672" y="3169920"/>
              <a:ext cx="7499985" cy="944880"/>
            </a:xfrm>
            <a:prstGeom prst="rect">
              <a:avLst/>
            </a:prstGeom>
          </p:spPr>
        </p:pic>
        <p:pic>
          <p:nvPicPr>
            <p:cNvPr id="16" name="Image 15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0824"/>
            <a:stretch/>
          </p:blipFill>
          <p:spPr>
            <a:xfrm>
              <a:off x="2628900" y="2781892"/>
              <a:ext cx="670993" cy="619982"/>
            </a:xfrm>
            <a:prstGeom prst="rect">
              <a:avLst/>
            </a:prstGeom>
          </p:spPr>
        </p:pic>
        <p:sp>
          <p:nvSpPr>
            <p:cNvPr id="17" name="ZoneTexte 16"/>
            <p:cNvSpPr txBox="1"/>
            <p:nvPr/>
          </p:nvSpPr>
          <p:spPr>
            <a:xfrm>
              <a:off x="3894634" y="2624527"/>
              <a:ext cx="713971" cy="336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b="1" dirty="0" err="1"/>
                <a:t>Phloem</a:t>
              </a:r>
              <a:endParaRPr lang="fr-BE" sz="900" b="1" dirty="0"/>
            </a:p>
          </p:txBody>
        </p:sp>
        <p:sp>
          <p:nvSpPr>
            <p:cNvPr id="18" name="ZoneTexte 17"/>
            <p:cNvSpPr txBox="1"/>
            <p:nvPr/>
          </p:nvSpPr>
          <p:spPr>
            <a:xfrm flipH="1">
              <a:off x="5264800" y="2423208"/>
              <a:ext cx="886136" cy="5376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b="1" dirty="0" err="1"/>
                <a:t>Expanding</a:t>
              </a:r>
              <a:endParaRPr lang="fr-BE" sz="900" b="1" dirty="0"/>
            </a:p>
            <a:p>
              <a:pPr algn="ctr"/>
              <a:r>
                <a:rPr lang="fr-BE" sz="900" b="1" dirty="0"/>
                <a:t> </a:t>
              </a:r>
              <a:r>
                <a:rPr lang="fr-BE" sz="900" b="1" dirty="0" err="1"/>
                <a:t>xylem</a:t>
              </a:r>
              <a:endParaRPr lang="en-GB" sz="900" b="1" dirty="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6697838" y="2624527"/>
              <a:ext cx="1174463" cy="336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200"/>
              </a:lvl1pPr>
            </a:lstStyle>
            <a:p>
              <a:r>
                <a:rPr lang="fr-BE" sz="900" b="1" dirty="0" err="1"/>
                <a:t>Lignified</a:t>
              </a:r>
              <a:r>
                <a:rPr lang="fr-BE" sz="900" b="1" dirty="0"/>
                <a:t> </a:t>
              </a:r>
              <a:r>
                <a:rPr lang="fr-BE" sz="900" b="1" dirty="0" err="1"/>
                <a:t>xylem</a:t>
              </a:r>
              <a:endParaRPr lang="en-GB" sz="900" b="1" dirty="0"/>
            </a:p>
          </p:txBody>
        </p:sp>
        <p:sp>
          <p:nvSpPr>
            <p:cNvPr id="20" name="Accolade ouvrante 19"/>
            <p:cNvSpPr/>
            <p:nvPr/>
          </p:nvSpPr>
          <p:spPr>
            <a:xfrm rot="5400000" flipV="1">
              <a:off x="4179742" y="2773945"/>
              <a:ext cx="104849" cy="463774"/>
            </a:xfrm>
            <a:prstGeom prst="lef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sz="900"/>
            </a:p>
          </p:txBody>
        </p:sp>
        <p:sp>
          <p:nvSpPr>
            <p:cNvPr id="21" name="Accolade ouvrante 20"/>
            <p:cNvSpPr/>
            <p:nvPr/>
          </p:nvSpPr>
          <p:spPr>
            <a:xfrm rot="5400000" flipV="1">
              <a:off x="4817966" y="2658962"/>
              <a:ext cx="107294" cy="696182"/>
            </a:xfrm>
            <a:prstGeom prst="lef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sz="900"/>
            </a:p>
          </p:txBody>
        </p:sp>
        <p:sp>
          <p:nvSpPr>
            <p:cNvPr id="22" name="Accolade ouvrante 21"/>
            <p:cNvSpPr/>
            <p:nvPr/>
          </p:nvSpPr>
          <p:spPr>
            <a:xfrm rot="5400000" flipV="1">
              <a:off x="5636464" y="2596115"/>
              <a:ext cx="104848" cy="819430"/>
            </a:xfrm>
            <a:prstGeom prst="lef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sz="900"/>
            </a:p>
          </p:txBody>
        </p:sp>
        <p:sp>
          <p:nvSpPr>
            <p:cNvPr id="23" name="Accolade ouvrante 22"/>
            <p:cNvSpPr/>
            <p:nvPr/>
          </p:nvSpPr>
          <p:spPr>
            <a:xfrm rot="5400000" flipV="1">
              <a:off x="7217615" y="1893866"/>
              <a:ext cx="104849" cy="2223931"/>
            </a:xfrm>
            <a:prstGeom prst="lef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sz="90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4467618" y="2624527"/>
              <a:ext cx="836353" cy="336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BE" sz="900" b="1" dirty="0"/>
                <a:t>Cambium</a:t>
              </a:r>
            </a:p>
          </p:txBody>
        </p:sp>
      </p:grpSp>
      <p:sp>
        <p:nvSpPr>
          <p:cNvPr id="26" name="ZoneTexte 25"/>
          <p:cNvSpPr txBox="1"/>
          <p:nvPr/>
        </p:nvSpPr>
        <p:spPr>
          <a:xfrm>
            <a:off x="457202" y="1293133"/>
            <a:ext cx="3802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dirty="0"/>
              <a:t>(a)</a:t>
            </a:r>
            <a:endParaRPr lang="en-US" sz="1400" dirty="0"/>
          </a:p>
        </p:txBody>
      </p:sp>
      <p:sp>
        <p:nvSpPr>
          <p:cNvPr id="27" name="ZoneTexte 26"/>
          <p:cNvSpPr txBox="1"/>
          <p:nvPr/>
        </p:nvSpPr>
        <p:spPr>
          <a:xfrm>
            <a:off x="579815" y="5410097"/>
            <a:ext cx="3882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dirty="0"/>
              <a:t>(b)</a:t>
            </a:r>
            <a:endParaRPr lang="en-US" sz="1400" dirty="0"/>
          </a:p>
        </p:txBody>
      </p:sp>
      <p:sp>
        <p:nvSpPr>
          <p:cNvPr id="28" name="ZoneTexte 27"/>
          <p:cNvSpPr txBox="1"/>
          <p:nvPr/>
        </p:nvSpPr>
        <p:spPr>
          <a:xfrm>
            <a:off x="553065" y="7050502"/>
            <a:ext cx="579596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GB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GB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lico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GT72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in poplar. (a) Expression profiles of 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GT72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different tissues and organs of 1-year-old 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GB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ichocarpa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analysed by RNA-Seq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aph was performed from raw data of (Shi et al., 2017) by calculating the average of transcript abundance (expressed in normalized counts-per-million) in three libraries of the same tissue (± SE). (b) Expression profile of poplar </a:t>
            </a:r>
            <a:r>
              <a:rPr lang="en-GB" sz="1200" i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GT72B</a:t>
            </a:r>
            <a:r>
              <a:rPr lang="en-GB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cros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stem of a 45-year-old 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GB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mula</a:t>
            </a:r>
            <a:r>
              <a:rPr lang="en-GB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results show average expression profile of samples taken from four independent naturally growing 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GB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mula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-25 indicate different samples corresponding to longitudinal tangential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yosection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Raw values were taken in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ndell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t al. (2017). This graphic was generated using Cluster 3 and visualized with Tree View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060553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56</Words>
  <Application>Microsoft Office PowerPoint</Application>
  <PresentationFormat>Format A4 (210 x 297 mm)</PresentationFormat>
  <Paragraphs>9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e baucher</dc:creator>
  <cp:lastModifiedBy>marie baucher</cp:lastModifiedBy>
  <cp:revision>2</cp:revision>
  <dcterms:created xsi:type="dcterms:W3CDTF">2020-05-29T16:17:34Z</dcterms:created>
  <dcterms:modified xsi:type="dcterms:W3CDTF">2020-06-25T07:18:09Z</dcterms:modified>
</cp:coreProperties>
</file>